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2" r:id="rId3"/>
    <p:sldId id="275" r:id="rId4"/>
    <p:sldId id="273" r:id="rId5"/>
    <p:sldId id="277" r:id="rId6"/>
    <p:sldId id="27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094A9-740C-49AB-9323-264FF1AA8E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93FBA6-3CB8-4A40-A537-E04C6C09CC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E563C-F103-4E71-BE05-71E0EADE00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E31920-6462-49B1-BF3D-1EDBBD911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1EF759-CFF6-4768-8C22-19BE7401B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729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6A7F1-A2E8-423D-B876-C823D6F52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C9F8C1-C76F-49AD-BAB0-30CDC11DF3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69EDE6-B617-45CC-82EA-2382E38F3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5C668-D684-412E-8D74-9EC7EDF4F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BCBE4-C6F5-4F22-9E19-9DE400DB7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78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43F87F-05C3-4659-81AB-5CD8F488A5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326817-CEDC-42FB-8196-63836ACE86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081502-AE6D-47AC-A3EC-233236ED6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30F4C-CEFA-4C83-91EC-15EE7EA7F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49D44E-D2B5-4A9E-9189-AA821F76C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690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63797B-6B74-4F9C-993F-B653951BE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D688FB-4AAF-4C2D-9785-AD4C73EBE1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D05CD1-C931-4D49-B247-D460BE5DD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406A4-80D3-4059-9098-8218D8CB9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FE43B9-2CF6-4CC0-B0D1-ACFC6F59C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880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6A1F3-63AD-4E16-AB6A-3B8FE2897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696DA8-0097-4908-8601-AC6D10C307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B6FDA5-E6B1-4ECD-90B5-7630DB789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A7086-CB19-4652-A3EA-18533CF0A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215CE9-E13B-4430-9799-954D11BC9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493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724CAE-FD5C-4546-9845-35C463DB50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28B5B0-1231-4F94-9A3B-21D551CE29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AE8DC0-5324-4A01-950C-056564E621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C8C4EB-80CD-4082-86D6-37D685524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05D4E1-2E15-4207-9FD3-8A253CE10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258CFC-7934-45D6-B472-12F437035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314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92E40-B018-4FB5-89CE-8676E5B622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6E5433-695A-42E9-8639-8B44AC0FD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4A8348-4EBE-4856-B7C0-562A614ACE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6C0807-F0C0-42EC-8AB3-FD5DE7331D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CB0D53-94C1-420C-ADBA-26E480FE52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462EFDA-03D1-4339-A250-9AA76FC39F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7F3E58-AB56-46A2-8B61-BFACFD4B9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FD1F99D-6EC3-45C9-87A2-8C9873E5F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421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8F52D-85E3-47E6-B523-B95E198153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E92C42-C790-4F89-90E2-44DAAC18D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A7432E-698D-4DA6-B579-DE2CC7115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35DA57-DB9B-45B8-9744-A3031E02F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589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646A0F-8FA5-4415-9A4F-484FB5C3B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26C615-6706-4C61-8F29-B248A4BDE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357D5C-2CD1-49D2-B771-0C1AB3EA5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097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D93F9-9EBB-4AC6-B615-B9B50ED44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4524CF-2620-4129-A3FB-BAABEAE684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6BA4C1-5807-45CB-B9A4-30B6E2FBC8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56D4B6-2EF1-4C37-B3D9-D8DD351A6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D92F51-1597-4CBD-AA31-7B4524C48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F6249A-9E28-46A6-8A10-CD82756F9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5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3237E-E640-4C7F-AA9E-7B7E821B6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B4C3F5-B564-41B9-B458-655CC25B21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BE130F-7181-449D-AD84-DFC2D49BB6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27864E-80CA-4CCB-8F7F-25C9F25AF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3A4EC0-96C8-47AA-9CCC-DA9A63F0A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41DEC1-3F2B-481C-BBD5-02BF2C333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664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930598-9402-4BF3-8235-B92D2B8C3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61F515-64D7-4FF7-8E13-DF4720B009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221A3D-84B1-4BF2-812A-5C3713270C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21A25-B1A3-499F-862E-636182079FA5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7EE6CE-D3C1-4630-8354-DB9964FFCA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89F1A0-FEDF-4586-B072-3488B46F6F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BC424-116B-4E72-A31D-BC575FB74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888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14">
            <a:extLst>
              <a:ext uri="{FF2B5EF4-FFF2-40B4-BE49-F238E27FC236}">
                <a16:creationId xmlns:a16="http://schemas.microsoft.com/office/drawing/2014/main" id="{84A06370-1493-4A35-8C21-E2739571D0BB}"/>
              </a:ext>
            </a:extLst>
          </p:cNvPr>
          <p:cNvSpPr txBox="1"/>
          <p:nvPr/>
        </p:nvSpPr>
        <p:spPr>
          <a:xfrm>
            <a:off x="9474856" y="9611"/>
            <a:ext cx="22028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A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84686D3D-1D65-38EE-552B-B6D9E607CCC9}"/>
              </a:ext>
            </a:extLst>
          </p:cNvPr>
          <p:cNvGrpSpPr/>
          <p:nvPr/>
        </p:nvGrpSpPr>
        <p:grpSpPr>
          <a:xfrm>
            <a:off x="1039488" y="-20469"/>
            <a:ext cx="8989054" cy="6868858"/>
            <a:chOff x="1039488" y="-20469"/>
            <a:chExt cx="8989054" cy="6868858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DD34BD4-05D3-4105-B878-E63412B301B3}"/>
                </a:ext>
              </a:extLst>
            </p:cNvPr>
            <p:cNvSpPr txBox="1"/>
            <p:nvPr/>
          </p:nvSpPr>
          <p:spPr>
            <a:xfrm>
              <a:off x="4299033" y="-20469"/>
              <a:ext cx="10150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mino acid</a:t>
              </a: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1E742223-B7CA-7462-AD3C-B138852A18A2}"/>
                </a:ext>
              </a:extLst>
            </p:cNvPr>
            <p:cNvGrpSpPr/>
            <p:nvPr/>
          </p:nvGrpSpPr>
          <p:grpSpPr>
            <a:xfrm>
              <a:off x="1039488" y="242587"/>
              <a:ext cx="8989054" cy="6605802"/>
              <a:chOff x="582288" y="203778"/>
              <a:chExt cx="8989054" cy="6605802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4F663478-37E7-D42F-B05B-B46A121763DB}"/>
                  </a:ext>
                </a:extLst>
              </p:cNvPr>
              <p:cNvGrpSpPr/>
              <p:nvPr/>
            </p:nvGrpSpPr>
            <p:grpSpPr>
              <a:xfrm>
                <a:off x="582288" y="203778"/>
                <a:ext cx="8827279" cy="3286274"/>
                <a:chOff x="582288" y="203778"/>
                <a:chExt cx="8827279" cy="3286274"/>
              </a:xfrm>
            </p:grpSpPr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374FB42A-07FC-934A-B95F-30B42B7DC9BE}"/>
                    </a:ext>
                  </a:extLst>
                </p:cNvPr>
                <p:cNvGrpSpPr/>
                <p:nvPr/>
              </p:nvGrpSpPr>
              <p:grpSpPr>
                <a:xfrm>
                  <a:off x="582288" y="203778"/>
                  <a:ext cx="2558849" cy="3286274"/>
                  <a:chOff x="582288" y="156218"/>
                  <a:chExt cx="2558849" cy="3286274"/>
                </a:xfrm>
              </p:grpSpPr>
              <p:sp>
                <p:nvSpPr>
                  <p:cNvPr id="4" name="TextBox 3">
                    <a:extLst>
                      <a:ext uri="{FF2B5EF4-FFF2-40B4-BE49-F238E27FC236}">
                        <a16:creationId xmlns:a16="http://schemas.microsoft.com/office/drawing/2014/main" id="{6FD5E222-C062-4D85-8EF8-AADE63DA40A8}"/>
                      </a:ext>
                    </a:extLst>
                  </p:cNvPr>
                  <p:cNvSpPr txBox="1"/>
                  <p:nvPr/>
                </p:nvSpPr>
                <p:spPr>
                  <a:xfrm>
                    <a:off x="1312770" y="156218"/>
                    <a:ext cx="1450662" cy="2561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spartic acid (Asp)</a:t>
                    </a:r>
                  </a:p>
                </p:txBody>
              </p:sp>
              <p:pic>
                <p:nvPicPr>
                  <p:cNvPr id="5" name="Picture 4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74CD56A6-2B15-3936-4EC4-4EFAA0BB91B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1596" t="10885"/>
                  <a:stretch/>
                </p:blipFill>
                <p:spPr>
                  <a:xfrm>
                    <a:off x="582288" y="379252"/>
                    <a:ext cx="2558849" cy="306324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EE843129-F82A-94F6-409F-F1D9254ECE80}"/>
                    </a:ext>
                  </a:extLst>
                </p:cNvPr>
                <p:cNvGrpSpPr/>
                <p:nvPr/>
              </p:nvGrpSpPr>
              <p:grpSpPr>
                <a:xfrm>
                  <a:off x="3903138" y="203778"/>
                  <a:ext cx="2525020" cy="3248456"/>
                  <a:chOff x="3905955" y="168704"/>
                  <a:chExt cx="2525020" cy="3248456"/>
                </a:xfrm>
              </p:grpSpPr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7EBF07F8-9193-4CDD-A368-C0FEDAEFA413}"/>
                      </a:ext>
                    </a:extLst>
                  </p:cNvPr>
                  <p:cNvSpPr txBox="1"/>
                  <p:nvPr/>
                </p:nvSpPr>
                <p:spPr>
                  <a:xfrm>
                    <a:off x="4898008" y="168704"/>
                    <a:ext cx="1072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teine (</a:t>
                    </a:r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  <p:pic>
                <p:nvPicPr>
                  <p:cNvPr id="9" name="Picture 8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0677D52B-9F47-D4C1-1B59-27D2D4EBC7E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1887" t="10692" r="654" b="761"/>
                  <a:stretch/>
                </p:blipFill>
                <p:spPr>
                  <a:xfrm>
                    <a:off x="3905955" y="353920"/>
                    <a:ext cx="2525020" cy="306324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8E9A4BCD-1230-89C3-ACDE-1E37149BE3ED}"/>
                    </a:ext>
                  </a:extLst>
                </p:cNvPr>
                <p:cNvGrpSpPr/>
                <p:nvPr/>
              </p:nvGrpSpPr>
              <p:grpSpPr>
                <a:xfrm>
                  <a:off x="6909041" y="204638"/>
                  <a:ext cx="2500526" cy="3247596"/>
                  <a:chOff x="7423028" y="133032"/>
                  <a:chExt cx="2500526" cy="3247596"/>
                </a:xfrm>
              </p:grpSpPr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0EB860BC-4692-4C6E-B7EB-8DE3D1118496}"/>
                      </a:ext>
                    </a:extLst>
                  </p:cNvPr>
                  <p:cNvSpPr txBox="1"/>
                  <p:nvPr/>
                </p:nvSpPr>
                <p:spPr>
                  <a:xfrm>
                    <a:off x="8185029" y="133032"/>
                    <a:ext cx="135646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mic acid (Glu)</a:t>
                    </a:r>
                  </a:p>
                </p:txBody>
              </p:sp>
              <p:pic>
                <p:nvPicPr>
                  <p:cNvPr id="14" name="Picture 13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DBE22313-BC8B-6DF6-F4F3-273AA9911E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481" t="10943" r="654" b="761"/>
                  <a:stretch/>
                </p:blipFill>
                <p:spPr>
                  <a:xfrm>
                    <a:off x="7423028" y="317388"/>
                    <a:ext cx="2500526" cy="3063240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07B8C85A-F0EE-5D67-7511-17B8BB953018}"/>
                  </a:ext>
                </a:extLst>
              </p:cNvPr>
              <p:cNvGrpSpPr/>
              <p:nvPr/>
            </p:nvGrpSpPr>
            <p:grpSpPr>
              <a:xfrm>
                <a:off x="647779" y="3550647"/>
                <a:ext cx="8923563" cy="3258933"/>
                <a:chOff x="647779" y="3550647"/>
                <a:chExt cx="8923563" cy="3258933"/>
              </a:xfrm>
            </p:grpSpPr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198EB1C2-DE04-8C4A-778B-5967A615B44B}"/>
                    </a:ext>
                  </a:extLst>
                </p:cNvPr>
                <p:cNvGrpSpPr/>
                <p:nvPr/>
              </p:nvGrpSpPr>
              <p:grpSpPr>
                <a:xfrm>
                  <a:off x="647779" y="3660397"/>
                  <a:ext cx="2427866" cy="3063240"/>
                  <a:chOff x="582288" y="3508599"/>
                  <a:chExt cx="2427866" cy="3150283"/>
                </a:xfrm>
              </p:grpSpPr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21BF76C5-8045-42D0-985A-D47DC5369977}"/>
                      </a:ext>
                    </a:extLst>
                  </p:cNvPr>
                  <p:cNvSpPr txBox="1"/>
                  <p:nvPr/>
                </p:nvSpPr>
                <p:spPr>
                  <a:xfrm>
                    <a:off x="1389531" y="3508599"/>
                    <a:ext cx="97174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ycine (</a:t>
                    </a:r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y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  <p:pic>
                <p:nvPicPr>
                  <p:cNvPr id="18" name="Picture 17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B3B1D002-E91A-9E1B-A935-7673B2AD571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481" t="11195"/>
                  <a:stretch/>
                </p:blipFill>
                <p:spPr>
                  <a:xfrm>
                    <a:off x="582288" y="3708650"/>
                    <a:ext cx="2427866" cy="2950232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ECC83B0E-0946-0E5F-52D6-A6FB8BDA1D8E}"/>
                    </a:ext>
                  </a:extLst>
                </p:cNvPr>
                <p:cNvGrpSpPr/>
                <p:nvPr/>
              </p:nvGrpSpPr>
              <p:grpSpPr>
                <a:xfrm>
                  <a:off x="7125208" y="3550647"/>
                  <a:ext cx="2446134" cy="3172990"/>
                  <a:chOff x="6954065" y="3588170"/>
                  <a:chExt cx="2520791" cy="3269830"/>
                </a:xfrm>
              </p:grpSpPr>
              <p:pic>
                <p:nvPicPr>
                  <p:cNvPr id="32" name="Picture 31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47AD8482-165C-8C84-0018-29F1B1EC26C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1907" t="10441" r="246" b="139"/>
                  <a:stretch/>
                </p:blipFill>
                <p:spPr>
                  <a:xfrm>
                    <a:off x="6954065" y="3794760"/>
                    <a:ext cx="2520791" cy="3063240"/>
                  </a:xfrm>
                  <a:prstGeom prst="rect">
                    <a:avLst/>
                  </a:prstGeom>
                </p:spPr>
              </p:pic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EF5A1974-D91F-EF30-92EE-450C486F0980}"/>
                      </a:ext>
                    </a:extLst>
                  </p:cNvPr>
                  <p:cNvSpPr txBox="1"/>
                  <p:nvPr/>
                </p:nvSpPr>
                <p:spPr>
                  <a:xfrm>
                    <a:off x="7695922" y="3588170"/>
                    <a:ext cx="1166591" cy="25373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hreonine (</a:t>
                    </a:r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hr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</p:grpSp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2F3C9146-7D88-EEFF-F745-63A7E7B5CC23}"/>
                    </a:ext>
                  </a:extLst>
                </p:cNvPr>
                <p:cNvGrpSpPr/>
                <p:nvPr/>
              </p:nvGrpSpPr>
              <p:grpSpPr>
                <a:xfrm>
                  <a:off x="3841833" y="3660397"/>
                  <a:ext cx="2517187" cy="3149183"/>
                  <a:chOff x="3841833" y="3660397"/>
                  <a:chExt cx="2517187" cy="3149183"/>
                </a:xfrm>
              </p:grpSpPr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826FF9F2-FDD7-4BF5-95F4-2C0557BE6D15}"/>
                      </a:ext>
                    </a:extLst>
                  </p:cNvPr>
                  <p:cNvSpPr txBox="1"/>
                  <p:nvPr/>
                </p:nvSpPr>
                <p:spPr>
                  <a:xfrm>
                    <a:off x="4759716" y="3660397"/>
                    <a:ext cx="96693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anine (Ala)</a:t>
                    </a:r>
                  </a:p>
                </p:txBody>
              </p:sp>
              <p:pic>
                <p:nvPicPr>
                  <p:cNvPr id="3" name="Picture 2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7C72646F-2361-977E-B259-D86DBCB5D24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167" t="11196" r="761" b="706"/>
                  <a:stretch/>
                </p:blipFill>
                <p:spPr>
                  <a:xfrm>
                    <a:off x="3841833" y="3837062"/>
                    <a:ext cx="2517187" cy="2972518"/>
                  </a:xfrm>
                  <a:prstGeom prst="rect">
                    <a:avLst/>
                  </a:prstGeom>
                </p:spPr>
              </p:pic>
            </p:grpSp>
          </p:grpSp>
        </p:grpSp>
      </p:grpSp>
    </p:spTree>
    <p:extLst>
      <p:ext uri="{BB962C8B-B14F-4D97-AF65-F5344CB8AC3E}">
        <p14:creationId xmlns:p14="http://schemas.microsoft.com/office/powerpoint/2010/main" val="2641001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>
            <a:extLst>
              <a:ext uri="{FF2B5EF4-FFF2-40B4-BE49-F238E27FC236}">
                <a16:creationId xmlns:a16="http://schemas.microsoft.com/office/drawing/2014/main" id="{EDF7A5C7-0CD1-83C3-7097-30A0F0A4AED2}"/>
              </a:ext>
            </a:extLst>
          </p:cNvPr>
          <p:cNvGrpSpPr/>
          <p:nvPr/>
        </p:nvGrpSpPr>
        <p:grpSpPr>
          <a:xfrm>
            <a:off x="76284" y="28670"/>
            <a:ext cx="12021388" cy="6446487"/>
            <a:chOff x="76284" y="28670"/>
            <a:chExt cx="12021388" cy="6446487"/>
          </a:xfrm>
        </p:grpSpPr>
        <p:sp>
          <p:nvSpPr>
            <p:cNvPr id="21" name="TextBox 14">
              <a:extLst>
                <a:ext uri="{FF2B5EF4-FFF2-40B4-BE49-F238E27FC236}">
                  <a16:creationId xmlns:a16="http://schemas.microsoft.com/office/drawing/2014/main" id="{84A06370-1493-4A35-8C21-E2739571D0BB}"/>
                </a:ext>
              </a:extLst>
            </p:cNvPr>
            <p:cNvSpPr txBox="1"/>
            <p:nvPr/>
          </p:nvSpPr>
          <p:spPr>
            <a:xfrm>
              <a:off x="9555130" y="28670"/>
              <a:ext cx="25330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: S6B</a:t>
              </a: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DA4B24D7-5838-7075-AFBD-D4D6CF8E76BF}"/>
                </a:ext>
              </a:extLst>
            </p:cNvPr>
            <p:cNvGrpSpPr/>
            <p:nvPr/>
          </p:nvGrpSpPr>
          <p:grpSpPr>
            <a:xfrm>
              <a:off x="76284" y="107044"/>
              <a:ext cx="12021388" cy="6368113"/>
              <a:chOff x="76284" y="107044"/>
              <a:chExt cx="12021388" cy="6368113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4AC023B-767A-4FD2-9094-744241D88035}"/>
                  </a:ext>
                </a:extLst>
              </p:cNvPr>
              <p:cNvSpPr txBox="1"/>
              <p:nvPr/>
            </p:nvSpPr>
            <p:spPr>
              <a:xfrm>
                <a:off x="103804" y="107044"/>
                <a:ext cx="15616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ino acid related</a:t>
                </a:r>
              </a:p>
            </p:txBody>
          </p:sp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D44754FB-27BD-8F69-1DA4-30A24F68C3FC}"/>
                  </a:ext>
                </a:extLst>
              </p:cNvPr>
              <p:cNvGrpSpPr/>
              <p:nvPr/>
            </p:nvGrpSpPr>
            <p:grpSpPr>
              <a:xfrm>
                <a:off x="76284" y="3672430"/>
                <a:ext cx="12021388" cy="2802727"/>
                <a:chOff x="76284" y="3672430"/>
                <a:chExt cx="12021388" cy="2802727"/>
              </a:xfrm>
            </p:grpSpPr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C77DA8D3-4873-EB1E-A078-A3F8C6954375}"/>
                    </a:ext>
                  </a:extLst>
                </p:cNvPr>
                <p:cNvGrpSpPr/>
                <p:nvPr/>
              </p:nvGrpSpPr>
              <p:grpSpPr>
                <a:xfrm>
                  <a:off x="2448645" y="3676902"/>
                  <a:ext cx="2296045" cy="2764085"/>
                  <a:chOff x="478678" y="3574984"/>
                  <a:chExt cx="2296045" cy="2764085"/>
                </a:xfrm>
              </p:grpSpPr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21946199-F595-4A1F-B901-3A8527214ED5}"/>
                      </a:ext>
                    </a:extLst>
                  </p:cNvPr>
                  <p:cNvSpPr txBox="1"/>
                  <p:nvPr/>
                </p:nvSpPr>
                <p:spPr>
                  <a:xfrm>
                    <a:off x="876257" y="3574984"/>
                    <a:ext cx="150714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omocysteine (</a:t>
                    </a:r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cys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  <p:pic>
                <p:nvPicPr>
                  <p:cNvPr id="15" name="Picture 14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206A2B27-79EE-9707-846E-2D167600571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153" t="11698" r="572" b="1247"/>
                  <a:stretch/>
                </p:blipFill>
                <p:spPr>
                  <a:xfrm>
                    <a:off x="478678" y="3787893"/>
                    <a:ext cx="2296045" cy="255117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4A624BED-15D3-C911-1D65-C91FD27917DF}"/>
                    </a:ext>
                  </a:extLst>
                </p:cNvPr>
                <p:cNvGrpSpPr/>
                <p:nvPr/>
              </p:nvGrpSpPr>
              <p:grpSpPr>
                <a:xfrm>
                  <a:off x="9801627" y="3672430"/>
                  <a:ext cx="2296045" cy="2768557"/>
                  <a:chOff x="4497783" y="3452555"/>
                  <a:chExt cx="2296045" cy="2768557"/>
                </a:xfrm>
              </p:grpSpPr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640864EF-390D-41F1-B07A-631AA871A093}"/>
                      </a:ext>
                    </a:extLst>
                  </p:cNvPr>
                  <p:cNvSpPr txBox="1"/>
                  <p:nvPr/>
                </p:nvSpPr>
                <p:spPr>
                  <a:xfrm>
                    <a:off x="5218692" y="3452555"/>
                    <a:ext cx="64633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urine</a:t>
                    </a:r>
                  </a:p>
                </p:txBody>
              </p:sp>
              <p:pic>
                <p:nvPicPr>
                  <p:cNvPr id="20" name="Picture 19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60A9B64A-74DB-63DE-E2D7-C408CDF3776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278" t="11905" r="530" b="696"/>
                  <a:stretch/>
                </p:blipFill>
                <p:spPr>
                  <a:xfrm>
                    <a:off x="4497783" y="3669936"/>
                    <a:ext cx="2296045" cy="255117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5DC4B5A1-E106-395F-D5E4-7698A9E8F29F}"/>
                    </a:ext>
                  </a:extLst>
                </p:cNvPr>
                <p:cNvGrpSpPr/>
                <p:nvPr/>
              </p:nvGrpSpPr>
              <p:grpSpPr>
                <a:xfrm>
                  <a:off x="4854485" y="3689756"/>
                  <a:ext cx="2338041" cy="2751231"/>
                  <a:chOff x="7967023" y="3482421"/>
                  <a:chExt cx="2338041" cy="2751231"/>
                </a:xfrm>
              </p:grpSpPr>
              <p:pic>
                <p:nvPicPr>
                  <p:cNvPr id="24" name="Picture 23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86DD13D0-0056-55CB-B60C-B0101E844F7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317" t="11447" r="572" b="276"/>
                  <a:stretch/>
                </p:blipFill>
                <p:spPr>
                  <a:xfrm>
                    <a:off x="7967023" y="3682476"/>
                    <a:ext cx="2331486" cy="2551176"/>
                  </a:xfrm>
                  <a:prstGeom prst="rect">
                    <a:avLst/>
                  </a:prstGeom>
                </p:spPr>
              </p:pic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EC9D4CB9-AC04-4C68-EE57-03F62B518DD1}"/>
                      </a:ext>
                    </a:extLst>
                  </p:cNvPr>
                  <p:cNvSpPr txBox="1"/>
                  <p:nvPr/>
                </p:nvSpPr>
                <p:spPr>
                  <a:xfrm>
                    <a:off x="8310205" y="3482421"/>
                    <a:ext cx="1994859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-Methylhistidine (3-Met-His)	</a:t>
                    </a:r>
                  </a:p>
                </p:txBody>
              </p:sp>
            </p:grpSp>
            <p:grpSp>
              <p:nvGrpSpPr>
                <p:cNvPr id="50" name="Group 49">
                  <a:extLst>
                    <a:ext uri="{FF2B5EF4-FFF2-40B4-BE49-F238E27FC236}">
                      <a16:creationId xmlns:a16="http://schemas.microsoft.com/office/drawing/2014/main" id="{914538A3-DA2E-F9CE-C508-C9F4BC3D60EF}"/>
                    </a:ext>
                  </a:extLst>
                </p:cNvPr>
                <p:cNvGrpSpPr/>
                <p:nvPr/>
              </p:nvGrpSpPr>
              <p:grpSpPr>
                <a:xfrm>
                  <a:off x="76284" y="3708690"/>
                  <a:ext cx="2351160" cy="2732297"/>
                  <a:chOff x="8187398" y="3602732"/>
                  <a:chExt cx="2351160" cy="2732297"/>
                </a:xfrm>
              </p:grpSpPr>
              <p:pic>
                <p:nvPicPr>
                  <p:cNvPr id="47" name="Picture 46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C5B85343-5B01-B11C-EDC7-A0645BA12E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680" t="11883" r="490" b="1257"/>
                  <a:stretch/>
                </p:blipFill>
                <p:spPr>
                  <a:xfrm>
                    <a:off x="8187398" y="3783853"/>
                    <a:ext cx="2287324" cy="2551176"/>
                  </a:xfrm>
                  <a:prstGeom prst="rect">
                    <a:avLst/>
                  </a:prstGeom>
                </p:spPr>
              </p:pic>
              <p:sp>
                <p:nvSpPr>
                  <p:cNvPr id="49" name="TextBox 48">
                    <a:extLst>
                      <a:ext uri="{FF2B5EF4-FFF2-40B4-BE49-F238E27FC236}">
                        <a16:creationId xmlns:a16="http://schemas.microsoft.com/office/drawing/2014/main" id="{093C1CA5-FE7C-14AB-6F5A-5A7F9CBE04E3}"/>
                      </a:ext>
                    </a:extLst>
                  </p:cNvPr>
                  <p:cNvSpPr txBox="1"/>
                  <p:nvPr/>
                </p:nvSpPr>
                <p:spPr>
                  <a:xfrm>
                    <a:off x="8285372" y="3602732"/>
                    <a:ext cx="2253186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hydroxyphenylalanine (DOPA)</a:t>
                    </a:r>
                  </a:p>
                </p:txBody>
              </p:sp>
            </p:grpSp>
            <p:grpSp>
              <p:nvGrpSpPr>
                <p:cNvPr id="55" name="Group 54">
                  <a:extLst>
                    <a:ext uri="{FF2B5EF4-FFF2-40B4-BE49-F238E27FC236}">
                      <a16:creationId xmlns:a16="http://schemas.microsoft.com/office/drawing/2014/main" id="{CA3FE267-2409-0D11-1657-E8B7E48C12FB}"/>
                    </a:ext>
                  </a:extLst>
                </p:cNvPr>
                <p:cNvGrpSpPr/>
                <p:nvPr/>
              </p:nvGrpSpPr>
              <p:grpSpPr>
                <a:xfrm>
                  <a:off x="7302321" y="3677760"/>
                  <a:ext cx="2296045" cy="2797397"/>
                  <a:chOff x="8062321" y="1540300"/>
                  <a:chExt cx="2296045" cy="2797397"/>
                </a:xfrm>
              </p:grpSpPr>
              <p:pic>
                <p:nvPicPr>
                  <p:cNvPr id="52" name="Picture 51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41156EBA-C462-DE4F-2A3F-3F2B5562838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1507" t="11883" r="653" b="276"/>
                  <a:stretch/>
                </p:blipFill>
                <p:spPr>
                  <a:xfrm>
                    <a:off x="8062321" y="1786521"/>
                    <a:ext cx="2296045" cy="2551176"/>
                  </a:xfrm>
                  <a:prstGeom prst="rect">
                    <a:avLst/>
                  </a:prstGeom>
                </p:spPr>
              </p:pic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1D793DF7-DDA2-A79C-E8A8-EC7FD5169CA0}"/>
                      </a:ext>
                    </a:extLst>
                  </p:cNvPr>
                  <p:cNvSpPr txBox="1"/>
                  <p:nvPr/>
                </p:nvSpPr>
                <p:spPr>
                  <a:xfrm>
                    <a:off x="8316624" y="1540300"/>
                    <a:ext cx="1580791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ans-4-Hydroxyproline</a:t>
                    </a:r>
                  </a:p>
                </p:txBody>
              </p:sp>
            </p:grpSp>
          </p:grpSp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D7026972-4D21-5EEC-593B-909B6A97BCE5}"/>
                  </a:ext>
                </a:extLst>
              </p:cNvPr>
              <p:cNvGrpSpPr/>
              <p:nvPr/>
            </p:nvGrpSpPr>
            <p:grpSpPr>
              <a:xfrm>
                <a:off x="76284" y="645548"/>
                <a:ext cx="9634515" cy="2759120"/>
                <a:chOff x="76284" y="645548"/>
                <a:chExt cx="9634515" cy="2759120"/>
              </a:xfrm>
            </p:grpSpPr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D961EB67-CD3F-3DDB-8859-9473551E1E4D}"/>
                    </a:ext>
                  </a:extLst>
                </p:cNvPr>
                <p:cNvGrpSpPr/>
                <p:nvPr/>
              </p:nvGrpSpPr>
              <p:grpSpPr>
                <a:xfrm>
                  <a:off x="2540341" y="664184"/>
                  <a:ext cx="2314144" cy="2718826"/>
                  <a:chOff x="4607895" y="190833"/>
                  <a:chExt cx="2314144" cy="3221484"/>
                </a:xfrm>
              </p:grpSpPr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40EEA4EA-1056-4A5F-92C0-6834D53D7D53}"/>
                      </a:ext>
                    </a:extLst>
                  </p:cNvPr>
                  <p:cNvSpPr txBox="1"/>
                  <p:nvPr/>
                </p:nvSpPr>
                <p:spPr>
                  <a:xfrm>
                    <a:off x="4982084" y="190833"/>
                    <a:ext cx="193995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-Aminovaleric acid (5-AVA)</a:t>
                    </a:r>
                  </a:p>
                </p:txBody>
              </p:sp>
              <p:pic>
                <p:nvPicPr>
                  <p:cNvPr id="8" name="Picture 7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786202FD-0D2D-EE45-1746-45C13BF06E9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072" t="11321" r="818" b="1247"/>
                  <a:stretch/>
                </p:blipFill>
                <p:spPr>
                  <a:xfrm>
                    <a:off x="4607895" y="389478"/>
                    <a:ext cx="2296044" cy="302283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72CF8AEF-7CE1-4B01-EAA3-903B6C33B869}"/>
                    </a:ext>
                  </a:extLst>
                </p:cNvPr>
                <p:cNvGrpSpPr/>
                <p:nvPr/>
              </p:nvGrpSpPr>
              <p:grpSpPr>
                <a:xfrm>
                  <a:off x="4981650" y="645548"/>
                  <a:ext cx="2296045" cy="2755849"/>
                  <a:chOff x="8240481" y="333371"/>
                  <a:chExt cx="2296045" cy="2755849"/>
                </a:xfrm>
              </p:grpSpPr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E6D9992D-78DD-4E0C-9DEA-343A6B379FDB}"/>
                      </a:ext>
                    </a:extLst>
                  </p:cNvPr>
                  <p:cNvSpPr txBox="1"/>
                  <p:nvPr/>
                </p:nvSpPr>
                <p:spPr>
                  <a:xfrm>
                    <a:off x="8922733" y="333371"/>
                    <a:ext cx="1032655" cy="26748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itrulline (</a:t>
                    </a:r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it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  <p:pic>
                <p:nvPicPr>
                  <p:cNvPr id="11" name="Picture 10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082AED3D-D849-F121-D313-E935189EF8E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235" t="11950" r="899" b="276"/>
                  <a:stretch/>
                </p:blipFill>
                <p:spPr>
                  <a:xfrm>
                    <a:off x="8240481" y="538044"/>
                    <a:ext cx="2296045" cy="255117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56" name="Group 55">
                  <a:extLst>
                    <a:ext uri="{FF2B5EF4-FFF2-40B4-BE49-F238E27FC236}">
                      <a16:creationId xmlns:a16="http://schemas.microsoft.com/office/drawing/2014/main" id="{C5E7B01F-788F-6FA6-933D-5DC53D0C3DE3}"/>
                    </a:ext>
                  </a:extLst>
                </p:cNvPr>
                <p:cNvGrpSpPr/>
                <p:nvPr/>
              </p:nvGrpSpPr>
              <p:grpSpPr>
                <a:xfrm>
                  <a:off x="76284" y="664184"/>
                  <a:ext cx="2536584" cy="2740484"/>
                  <a:chOff x="2552361" y="3730795"/>
                  <a:chExt cx="2536584" cy="2740484"/>
                </a:xfrm>
              </p:grpSpPr>
              <p:pic>
                <p:nvPicPr>
                  <p:cNvPr id="43" name="Picture 42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1A6FE545-F222-6203-0E28-E9564C64CA1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680" t="10459" b="1258"/>
                  <a:stretch/>
                </p:blipFill>
                <p:spPr>
                  <a:xfrm>
                    <a:off x="2561632" y="3920103"/>
                    <a:ext cx="2287324" cy="2551176"/>
                  </a:xfrm>
                  <a:prstGeom prst="rect">
                    <a:avLst/>
                  </a:prstGeom>
                </p:spPr>
              </p:pic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EBCEDD1C-14C5-CF22-3FCB-0F73CF54FC5E}"/>
                      </a:ext>
                    </a:extLst>
                  </p:cNvPr>
                  <p:cNvSpPr txBox="1"/>
                  <p:nvPr/>
                </p:nvSpPr>
                <p:spPr>
                  <a:xfrm>
                    <a:off x="2552361" y="3730795"/>
                    <a:ext cx="2536584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symmetric dimethylarginine (ADMA)</a:t>
                    </a:r>
                  </a:p>
                </p:txBody>
              </p:sp>
            </p:grpSp>
            <p:grpSp>
              <p:nvGrpSpPr>
                <p:cNvPr id="67" name="Group 66">
                  <a:extLst>
                    <a:ext uri="{FF2B5EF4-FFF2-40B4-BE49-F238E27FC236}">
                      <a16:creationId xmlns:a16="http://schemas.microsoft.com/office/drawing/2014/main" id="{7F5F3611-B4C1-01B2-9836-1E301100F8DC}"/>
                    </a:ext>
                  </a:extLst>
                </p:cNvPr>
                <p:cNvGrpSpPr/>
                <p:nvPr/>
              </p:nvGrpSpPr>
              <p:grpSpPr>
                <a:xfrm>
                  <a:off x="7378809" y="645548"/>
                  <a:ext cx="2331990" cy="2737462"/>
                  <a:chOff x="5104091" y="3717215"/>
                  <a:chExt cx="2331990" cy="3212490"/>
                </a:xfrm>
              </p:grpSpPr>
              <p:pic>
                <p:nvPicPr>
                  <p:cNvPr id="65" name="Picture 64" descr="A screenshot of a diagram&#10;&#10;Description automatically generated">
                    <a:extLst>
                      <a:ext uri="{FF2B5EF4-FFF2-40B4-BE49-F238E27FC236}">
                        <a16:creationId xmlns:a16="http://schemas.microsoft.com/office/drawing/2014/main" id="{1E4EA7B4-330E-FB2C-4951-E303970E881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093" t="10818" b="418"/>
                  <a:stretch/>
                </p:blipFill>
                <p:spPr>
                  <a:xfrm>
                    <a:off x="5104091" y="3901595"/>
                    <a:ext cx="2331990" cy="3028110"/>
                  </a:xfrm>
                  <a:prstGeom prst="rect">
                    <a:avLst/>
                  </a:prstGeom>
                </p:spPr>
              </p:pic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462167A2-3239-DB32-6EC8-E50D4859E205}"/>
                      </a:ext>
                    </a:extLst>
                  </p:cNvPr>
                  <p:cNvSpPr txBox="1"/>
                  <p:nvPr/>
                </p:nvSpPr>
                <p:spPr>
                  <a:xfrm>
                    <a:off x="5789124" y="3717215"/>
                    <a:ext cx="64633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stine</a:t>
                    </a: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3536995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D9828EF-97F7-2182-0086-6CCDB9911804}"/>
              </a:ext>
            </a:extLst>
          </p:cNvPr>
          <p:cNvGrpSpPr/>
          <p:nvPr/>
        </p:nvGrpSpPr>
        <p:grpSpPr>
          <a:xfrm>
            <a:off x="127116" y="-24072"/>
            <a:ext cx="11785624" cy="6489625"/>
            <a:chOff x="127116" y="-24072"/>
            <a:chExt cx="11785624" cy="6489625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104868E-D587-4D5B-8BC5-11B21B013716}"/>
                </a:ext>
              </a:extLst>
            </p:cNvPr>
            <p:cNvSpPr txBox="1"/>
            <p:nvPr/>
          </p:nvSpPr>
          <p:spPr>
            <a:xfrm>
              <a:off x="127116" y="11605"/>
              <a:ext cx="8338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atty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id</a:t>
              </a:r>
            </a:p>
          </p:txBody>
        </p:sp>
        <p:sp>
          <p:nvSpPr>
            <p:cNvPr id="18" name="TextBox 14">
              <a:extLst>
                <a:ext uri="{FF2B5EF4-FFF2-40B4-BE49-F238E27FC236}">
                  <a16:creationId xmlns:a16="http://schemas.microsoft.com/office/drawing/2014/main" id="{84A06370-1493-4A35-8C21-E2739571D0BB}"/>
                </a:ext>
              </a:extLst>
            </p:cNvPr>
            <p:cNvSpPr txBox="1"/>
            <p:nvPr/>
          </p:nvSpPr>
          <p:spPr>
            <a:xfrm>
              <a:off x="9709893" y="-24072"/>
              <a:ext cx="22028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: S6C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0DBE4A4-7843-0E05-15C4-45D31580E848}"/>
                </a:ext>
              </a:extLst>
            </p:cNvPr>
            <p:cNvGrpSpPr/>
            <p:nvPr/>
          </p:nvGrpSpPr>
          <p:grpSpPr>
            <a:xfrm>
              <a:off x="1231087" y="276941"/>
              <a:ext cx="2298872" cy="3019990"/>
              <a:chOff x="1177097" y="106663"/>
              <a:chExt cx="2298872" cy="3019990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2E8336C3-F5C5-4FA1-9BDC-06F88900F146}"/>
                  </a:ext>
                </a:extLst>
              </p:cNvPr>
              <p:cNvSpPr txBox="1"/>
              <p:nvPr/>
            </p:nvSpPr>
            <p:spPr>
              <a:xfrm>
                <a:off x="1742537" y="106663"/>
                <a:ext cx="1582575" cy="2466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rachidonic acid (AA)</a:t>
                </a:r>
              </a:p>
            </p:txBody>
          </p:sp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359354AD-A25B-26E0-D301-FD666ACB2D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235" t="11321" r="491" b="969"/>
              <a:stretch/>
            </p:blipFill>
            <p:spPr>
              <a:xfrm>
                <a:off x="1177097" y="353317"/>
                <a:ext cx="2298872" cy="2773336"/>
              </a:xfrm>
              <a:prstGeom prst="rect">
                <a:avLst/>
              </a:prstGeom>
            </p:spPr>
          </p:pic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03F94641-899A-29EE-5F6C-53CC5B217B85}"/>
                </a:ext>
              </a:extLst>
            </p:cNvPr>
            <p:cNvGrpSpPr/>
            <p:nvPr/>
          </p:nvGrpSpPr>
          <p:grpSpPr>
            <a:xfrm>
              <a:off x="4648258" y="302618"/>
              <a:ext cx="2331580" cy="2994313"/>
              <a:chOff x="4749522" y="129817"/>
              <a:chExt cx="2331580" cy="2994313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EC7F7A7-262F-4517-8FD6-C0559C78ED7B}"/>
                  </a:ext>
                </a:extLst>
              </p:cNvPr>
              <p:cNvSpPr txBox="1"/>
              <p:nvPr/>
            </p:nvSpPr>
            <p:spPr>
              <a:xfrm>
                <a:off x="5085043" y="129817"/>
                <a:ext cx="19960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cosahexaenoic acid (DHA) </a:t>
                </a:r>
              </a:p>
            </p:txBody>
          </p:sp>
          <p:pic>
            <p:nvPicPr>
              <p:cNvPr id="10" name="Picture 9" descr="A comparison of a 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B9EB613B-E6FB-717A-9F9A-0F3959CA9B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317" t="10943" b="970"/>
              <a:stretch/>
            </p:blipFill>
            <p:spPr>
              <a:xfrm>
                <a:off x="4749522" y="327376"/>
                <a:ext cx="2328306" cy="2796754"/>
              </a:xfrm>
              <a:prstGeom prst="rect">
                <a:avLst/>
              </a:prstGeom>
            </p:spPr>
          </p:pic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FF22B6F-5397-18C3-A018-67447B19CAB2}"/>
                </a:ext>
              </a:extLst>
            </p:cNvPr>
            <p:cNvGrpSpPr/>
            <p:nvPr/>
          </p:nvGrpSpPr>
          <p:grpSpPr>
            <a:xfrm>
              <a:off x="7869711" y="302618"/>
              <a:ext cx="2356310" cy="3004106"/>
              <a:chOff x="8154382" y="120024"/>
              <a:chExt cx="2356310" cy="3004106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D0DE9C6-A784-4DE5-95C1-9B07A6FF98E3}"/>
                  </a:ext>
                </a:extLst>
              </p:cNvPr>
              <p:cNvSpPr txBox="1"/>
              <p:nvPr/>
            </p:nvSpPr>
            <p:spPr>
              <a:xfrm>
                <a:off x="8977000" y="120024"/>
                <a:ext cx="7328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 (20:3)</a:t>
                </a:r>
              </a:p>
            </p:txBody>
          </p:sp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37A6F29C-14C7-228B-B9D0-495EF0D55A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235" t="11069" b="969"/>
              <a:stretch/>
            </p:blipFill>
            <p:spPr>
              <a:xfrm>
                <a:off x="8154382" y="302618"/>
                <a:ext cx="2356310" cy="2821512"/>
              </a:xfrm>
              <a:prstGeom prst="rect">
                <a:avLst/>
              </a:prstGeom>
            </p:spPr>
          </p:pic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D7E8D72D-7380-AFE0-8CFC-166D037AB602}"/>
                </a:ext>
              </a:extLst>
            </p:cNvPr>
            <p:cNvGrpSpPr/>
            <p:nvPr/>
          </p:nvGrpSpPr>
          <p:grpSpPr>
            <a:xfrm>
              <a:off x="1115157" y="3419446"/>
              <a:ext cx="2360898" cy="3046107"/>
              <a:chOff x="1064895" y="3172792"/>
              <a:chExt cx="2360898" cy="3046107"/>
            </a:xfrm>
          </p:grpSpPr>
          <p:pic>
            <p:nvPicPr>
              <p:cNvPr id="19" name="Picture 18" descr="A screenshot of a graph&#10;&#10;Description automatically generated">
                <a:extLst>
                  <a:ext uri="{FF2B5EF4-FFF2-40B4-BE49-F238E27FC236}">
                    <a16:creationId xmlns:a16="http://schemas.microsoft.com/office/drawing/2014/main" id="{043ED08E-3926-B35F-2A94-7D9E9C2290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317" t="10692" r="409" b="970"/>
              <a:stretch/>
            </p:blipFill>
            <p:spPr>
              <a:xfrm>
                <a:off x="1064895" y="3350313"/>
                <a:ext cx="2360898" cy="2868586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31A9994-F2C4-64D2-C4C4-560EF5930448}"/>
                  </a:ext>
                </a:extLst>
              </p:cNvPr>
              <p:cNvSpPr txBox="1"/>
              <p:nvPr/>
            </p:nvSpPr>
            <p:spPr>
              <a:xfrm>
                <a:off x="1878897" y="3172792"/>
                <a:ext cx="7328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 (18:2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90393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B9BA656-CE97-77ED-1DEA-1E65A82EE470}"/>
              </a:ext>
            </a:extLst>
          </p:cNvPr>
          <p:cNvGrpSpPr/>
          <p:nvPr/>
        </p:nvGrpSpPr>
        <p:grpSpPr>
          <a:xfrm>
            <a:off x="81233" y="9611"/>
            <a:ext cx="11596470" cy="6700787"/>
            <a:chOff x="81233" y="9611"/>
            <a:chExt cx="11596470" cy="6700787"/>
          </a:xfrm>
        </p:grpSpPr>
        <p:sp>
          <p:nvSpPr>
            <p:cNvPr id="21" name="TextBox 14">
              <a:extLst>
                <a:ext uri="{FF2B5EF4-FFF2-40B4-BE49-F238E27FC236}">
                  <a16:creationId xmlns:a16="http://schemas.microsoft.com/office/drawing/2014/main" id="{84A06370-1493-4A35-8C21-E2739571D0BB}"/>
                </a:ext>
              </a:extLst>
            </p:cNvPr>
            <p:cNvSpPr txBox="1"/>
            <p:nvPr/>
          </p:nvSpPr>
          <p:spPr>
            <a:xfrm>
              <a:off x="9474856" y="9611"/>
              <a:ext cx="22028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: S6D</a:t>
              </a: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7F5AF674-453C-4AD5-94DA-FE7AEE5C903A}"/>
                </a:ext>
              </a:extLst>
            </p:cNvPr>
            <p:cNvGrpSpPr/>
            <p:nvPr/>
          </p:nvGrpSpPr>
          <p:grpSpPr>
            <a:xfrm>
              <a:off x="449507" y="3473926"/>
              <a:ext cx="9643900" cy="3236472"/>
              <a:chOff x="97814" y="37122"/>
              <a:chExt cx="9643900" cy="3236472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DC50296B-ABC5-4A1E-A3CA-CCF5A9562324}"/>
                  </a:ext>
                </a:extLst>
              </p:cNvPr>
              <p:cNvSpPr txBox="1"/>
              <p:nvPr/>
            </p:nvSpPr>
            <p:spPr>
              <a:xfrm>
                <a:off x="97814" y="37122"/>
                <a:ext cx="1407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iogenic amines</a:t>
                </a:r>
              </a:p>
            </p:txBody>
          </p:sp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9DB4B1ED-790A-42AC-01CF-198ED3FA3935}"/>
                  </a:ext>
                </a:extLst>
              </p:cNvPr>
              <p:cNvGrpSpPr/>
              <p:nvPr/>
            </p:nvGrpSpPr>
            <p:grpSpPr>
              <a:xfrm>
                <a:off x="1661738" y="320304"/>
                <a:ext cx="8079976" cy="2953290"/>
                <a:chOff x="1297181" y="222497"/>
                <a:chExt cx="8079976" cy="2953290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27B6E8C4-90C7-1905-4FEB-C3CF2849BEFA}"/>
                    </a:ext>
                  </a:extLst>
                </p:cNvPr>
                <p:cNvGrpSpPr/>
                <p:nvPr/>
              </p:nvGrpSpPr>
              <p:grpSpPr>
                <a:xfrm>
                  <a:off x="1297181" y="249588"/>
                  <a:ext cx="2260784" cy="2906548"/>
                  <a:chOff x="1083856" y="416468"/>
                  <a:chExt cx="2260784" cy="2906548"/>
                </a:xfrm>
              </p:grpSpPr>
              <p:sp>
                <p:nvSpPr>
                  <p:cNvPr id="8" name="TextBox 7">
                    <a:extLst>
                      <a:ext uri="{FF2B5EF4-FFF2-40B4-BE49-F238E27FC236}">
                        <a16:creationId xmlns:a16="http://schemas.microsoft.com/office/drawing/2014/main" id="{A47DDB39-DF2D-420B-8A3E-49194C6671AE}"/>
                      </a:ext>
                    </a:extLst>
                  </p:cNvPr>
                  <p:cNvSpPr txBox="1"/>
                  <p:nvPr/>
                </p:nvSpPr>
                <p:spPr>
                  <a:xfrm>
                    <a:off x="1939753" y="416468"/>
                    <a:ext cx="1014877" cy="25027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eta-alanine</a:t>
                    </a:r>
                  </a:p>
                </p:txBody>
              </p:sp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8C78D11E-2AE6-BFE6-2607-E69D7380EDC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154" t="11195"/>
                  <a:stretch/>
                </p:blipFill>
                <p:spPr>
                  <a:xfrm>
                    <a:off x="1083856" y="594598"/>
                    <a:ext cx="2260784" cy="272841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DF13A656-269A-D4A1-DA5D-4C9940A02753}"/>
                    </a:ext>
                  </a:extLst>
                </p:cNvPr>
                <p:cNvGrpSpPr/>
                <p:nvPr/>
              </p:nvGrpSpPr>
              <p:grpSpPr>
                <a:xfrm>
                  <a:off x="4139565" y="249588"/>
                  <a:ext cx="2276368" cy="2907124"/>
                  <a:chOff x="3418703" y="442983"/>
                  <a:chExt cx="2276368" cy="2907124"/>
                </a:xfrm>
              </p:grpSpPr>
              <p:pic>
                <p:nvPicPr>
                  <p:cNvPr id="10" name="Picture 9">
                    <a:extLst>
                      <a:ext uri="{FF2B5EF4-FFF2-40B4-BE49-F238E27FC236}">
                        <a16:creationId xmlns:a16="http://schemas.microsoft.com/office/drawing/2014/main" id="{1B9531B2-1D17-4639-BF31-C2A6CC26BCD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317" t="11824" r="490" b="140"/>
                  <a:stretch/>
                </p:blipFill>
                <p:spPr>
                  <a:xfrm>
                    <a:off x="3418703" y="662689"/>
                    <a:ext cx="2215562" cy="2687418"/>
                  </a:xfrm>
                  <a:prstGeom prst="rect">
                    <a:avLst/>
                  </a:prstGeom>
                </p:spPr>
              </p:pic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9D4C6537-44AF-5EC0-3CA5-D451F83025F1}"/>
                      </a:ext>
                    </a:extLst>
                  </p:cNvPr>
                  <p:cNvSpPr txBox="1"/>
                  <p:nvPr/>
                </p:nvSpPr>
                <p:spPr>
                  <a:xfrm>
                    <a:off x="3695899" y="442983"/>
                    <a:ext cx="1999172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l-GR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γ-</a:t>
                    </a:r>
                    <a:r>
                      <a:rPr lang="en-US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minobutyric acid (GABA) 	</a:t>
                    </a:r>
                  </a:p>
                </p:txBody>
              </p:sp>
            </p:grpSp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8E07CE2E-3280-0047-D85E-EDB1489B262D}"/>
                    </a:ext>
                  </a:extLst>
                </p:cNvPr>
                <p:cNvGrpSpPr/>
                <p:nvPr/>
              </p:nvGrpSpPr>
              <p:grpSpPr>
                <a:xfrm>
                  <a:off x="7128325" y="222497"/>
                  <a:ext cx="2248832" cy="2953290"/>
                  <a:chOff x="1830213" y="3469061"/>
                  <a:chExt cx="2248832" cy="2953290"/>
                </a:xfrm>
              </p:grpSpPr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089BC241-53C3-4B64-A19D-547DA78B2691}"/>
                      </a:ext>
                    </a:extLst>
                  </p:cNvPr>
                  <p:cNvSpPr txBox="1"/>
                  <p:nvPr/>
                </p:nvSpPr>
                <p:spPr>
                  <a:xfrm>
                    <a:off x="2571351" y="3469061"/>
                    <a:ext cx="76655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permine</a:t>
                    </a:r>
                  </a:p>
                </p:txBody>
              </p:sp>
              <p:pic>
                <p:nvPicPr>
                  <p:cNvPr id="18" name="Picture 17" descr="A comparison of a diagram&#10;&#10;Description automatically generated with medium confidence">
                    <a:extLst>
                      <a:ext uri="{FF2B5EF4-FFF2-40B4-BE49-F238E27FC236}">
                        <a16:creationId xmlns:a16="http://schemas.microsoft.com/office/drawing/2014/main" id="{49F1FDB2-C570-1381-F17B-8B71FB92990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317" t="10943" b="140"/>
                  <a:stretch/>
                </p:blipFill>
                <p:spPr>
                  <a:xfrm>
                    <a:off x="1830213" y="3695631"/>
                    <a:ext cx="2248832" cy="2726720"/>
                  </a:xfrm>
                  <a:prstGeom prst="rect">
                    <a:avLst/>
                  </a:prstGeom>
                </p:spPr>
              </p:pic>
            </p:grpSp>
          </p:grp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DB327053-C660-EFD2-601C-968D051919A4}"/>
                </a:ext>
              </a:extLst>
            </p:cNvPr>
            <p:cNvGrpSpPr/>
            <p:nvPr/>
          </p:nvGrpSpPr>
          <p:grpSpPr>
            <a:xfrm>
              <a:off x="81233" y="78845"/>
              <a:ext cx="11596470" cy="3395081"/>
              <a:chOff x="0" y="3273594"/>
              <a:chExt cx="11596470" cy="3395081"/>
            </a:xfrm>
          </p:grpSpPr>
          <p:grpSp>
            <p:nvGrpSpPr>
              <p:cNvPr id="69" name="Group 68">
                <a:extLst>
                  <a:ext uri="{FF2B5EF4-FFF2-40B4-BE49-F238E27FC236}">
                    <a16:creationId xmlns:a16="http://schemas.microsoft.com/office/drawing/2014/main" id="{2E2868E1-1CDE-0389-BDBC-C88B502144D0}"/>
                  </a:ext>
                </a:extLst>
              </p:cNvPr>
              <p:cNvGrpSpPr/>
              <p:nvPr/>
            </p:nvGrpSpPr>
            <p:grpSpPr>
              <a:xfrm>
                <a:off x="0" y="3273594"/>
                <a:ext cx="9068141" cy="3395081"/>
                <a:chOff x="0" y="3273594"/>
                <a:chExt cx="9068141" cy="3395081"/>
              </a:xfrm>
            </p:grpSpPr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52EFF32B-123D-E06A-DE23-DC7A255663EB}"/>
                    </a:ext>
                  </a:extLst>
                </p:cNvPr>
                <p:cNvSpPr txBox="1"/>
                <p:nvPr/>
              </p:nvSpPr>
              <p:spPr>
                <a:xfrm>
                  <a:off x="0" y="3273594"/>
                  <a:ext cx="14061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rboxylic acids</a:t>
                  </a:r>
                </a:p>
              </p:txBody>
            </p:sp>
            <p:grpSp>
              <p:nvGrpSpPr>
                <p:cNvPr id="45" name="Group 44">
                  <a:extLst>
                    <a:ext uri="{FF2B5EF4-FFF2-40B4-BE49-F238E27FC236}">
                      <a16:creationId xmlns:a16="http://schemas.microsoft.com/office/drawing/2014/main" id="{E8675733-3CD1-26E8-C262-C4743D285D42}"/>
                    </a:ext>
                  </a:extLst>
                </p:cNvPr>
                <p:cNvGrpSpPr/>
                <p:nvPr/>
              </p:nvGrpSpPr>
              <p:grpSpPr>
                <a:xfrm>
                  <a:off x="3549745" y="3789457"/>
                  <a:ext cx="2184844" cy="2827112"/>
                  <a:chOff x="3026562" y="3749875"/>
                  <a:chExt cx="2184844" cy="2827112"/>
                </a:xfrm>
              </p:grpSpPr>
              <p:pic>
                <p:nvPicPr>
                  <p:cNvPr id="35" name="Picture 34" descr="A screenshot of a diagram&#10;&#10;Description automatically generated">
                    <a:extLst>
                      <a:ext uri="{FF2B5EF4-FFF2-40B4-BE49-F238E27FC236}">
                        <a16:creationId xmlns:a16="http://schemas.microsoft.com/office/drawing/2014/main" id="{6F6DDA8D-5547-6648-9265-F9D0EA21A09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481" t="11321" r="736" b="1132"/>
                  <a:stretch/>
                </p:blipFill>
                <p:spPr>
                  <a:xfrm>
                    <a:off x="3026562" y="3918505"/>
                    <a:ext cx="2184844" cy="2658482"/>
                  </a:xfrm>
                  <a:prstGeom prst="rect">
                    <a:avLst/>
                  </a:prstGeom>
                </p:spPr>
              </p:pic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B3711ECA-A677-5900-D520-6BDDA3DF9689}"/>
                      </a:ext>
                    </a:extLst>
                  </p:cNvPr>
                  <p:cNvSpPr txBox="1"/>
                  <p:nvPr/>
                </p:nvSpPr>
                <p:spPr>
                  <a:xfrm>
                    <a:off x="3668383" y="3749875"/>
                    <a:ext cx="1257300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ctic acid (Lac)	</a:t>
                    </a:r>
                  </a:p>
                </p:txBody>
              </p:sp>
            </p:grpSp>
            <p:grpSp>
              <p:nvGrpSpPr>
                <p:cNvPr id="46" name="Group 45">
                  <a:extLst>
                    <a:ext uri="{FF2B5EF4-FFF2-40B4-BE49-F238E27FC236}">
                      <a16:creationId xmlns:a16="http://schemas.microsoft.com/office/drawing/2014/main" id="{71BD6D25-C4D1-9F9A-C13C-F76F51F616F2}"/>
                    </a:ext>
                  </a:extLst>
                </p:cNvPr>
                <p:cNvGrpSpPr/>
                <p:nvPr/>
              </p:nvGrpSpPr>
              <p:grpSpPr>
                <a:xfrm>
                  <a:off x="660049" y="3722062"/>
                  <a:ext cx="2198346" cy="2886350"/>
                  <a:chOff x="380961" y="3726940"/>
                  <a:chExt cx="2198346" cy="2886350"/>
                </a:xfrm>
              </p:grpSpPr>
              <p:pic>
                <p:nvPicPr>
                  <p:cNvPr id="29" name="Picture 28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63848140-E1E4-7BE8-BA53-9D4283BD5C7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536" t="11561"/>
                  <a:stretch/>
                </p:blipFill>
                <p:spPr>
                  <a:xfrm>
                    <a:off x="380961" y="3949930"/>
                    <a:ext cx="2198346" cy="2663360"/>
                  </a:xfrm>
                  <a:prstGeom prst="rect">
                    <a:avLst/>
                  </a:prstGeom>
                </p:spPr>
              </p:pic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8F9A7CEC-0EF8-C6EE-4BA5-22FDFCAC0BCE}"/>
                      </a:ext>
                    </a:extLst>
                  </p:cNvPr>
                  <p:cNvGrpSpPr/>
                  <p:nvPr/>
                </p:nvGrpSpPr>
                <p:grpSpPr>
                  <a:xfrm>
                    <a:off x="701413" y="3726940"/>
                    <a:ext cx="1726160" cy="246222"/>
                    <a:chOff x="475436" y="3676333"/>
                    <a:chExt cx="1726160" cy="246222"/>
                  </a:xfrm>
                </p:grpSpPr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7828301F-EC1C-8121-9D09-2CA6840B72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97181" y="3676333"/>
                      <a:ext cx="90441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on</a:t>
                      </a:r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)</a:t>
                      </a:r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3FFC28D6-BC68-217B-33D9-9E7D43F60F9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5436" y="3676334"/>
                      <a:ext cx="104164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onitic acid</a:t>
                      </a:r>
                    </a:p>
                  </p:txBody>
                </p:sp>
              </p:grpSp>
            </p:grpSp>
            <p:grpSp>
              <p:nvGrpSpPr>
                <p:cNvPr id="56" name="Group 55">
                  <a:extLst>
                    <a:ext uri="{FF2B5EF4-FFF2-40B4-BE49-F238E27FC236}">
                      <a16:creationId xmlns:a16="http://schemas.microsoft.com/office/drawing/2014/main" id="{B058A604-E17A-6EA0-7227-17788C267DF6}"/>
                    </a:ext>
                  </a:extLst>
                </p:cNvPr>
                <p:cNvGrpSpPr/>
                <p:nvPr/>
              </p:nvGrpSpPr>
              <p:grpSpPr>
                <a:xfrm>
                  <a:off x="6360213" y="3789457"/>
                  <a:ext cx="2707928" cy="2879218"/>
                  <a:chOff x="6384760" y="3792098"/>
                  <a:chExt cx="2530336" cy="2690392"/>
                </a:xfrm>
              </p:grpSpPr>
              <p:pic>
                <p:nvPicPr>
                  <p:cNvPr id="48" name="Picture 47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0F4317F3-711D-6371-7574-DA5A6F773D6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563" t="11446" b="1383"/>
                  <a:stretch/>
                </p:blipFill>
                <p:spPr>
                  <a:xfrm>
                    <a:off x="6446176" y="3996094"/>
                    <a:ext cx="2080953" cy="2486396"/>
                  </a:xfrm>
                  <a:prstGeom prst="rect">
                    <a:avLst/>
                  </a:prstGeom>
                </p:spPr>
              </p:pic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2B44744E-16AC-B0BD-21E4-67D48AEE0A04}"/>
                      </a:ext>
                    </a:extLst>
                  </p:cNvPr>
                  <p:cNvSpPr txBox="1"/>
                  <p:nvPr/>
                </p:nvSpPr>
                <p:spPr>
                  <a:xfrm>
                    <a:off x="6384760" y="3792098"/>
                    <a:ext cx="2530336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-Hydroxyglutaric acid (OH-</a:t>
                    </a:r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cid</a:t>
                    </a:r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</a:p>
                </p:txBody>
              </p:sp>
            </p:grpSp>
          </p:grp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51BC3055-4A90-7439-3A19-5D15401F1122}"/>
                  </a:ext>
                </a:extLst>
              </p:cNvPr>
              <p:cNvGrpSpPr/>
              <p:nvPr/>
            </p:nvGrpSpPr>
            <p:grpSpPr>
              <a:xfrm>
                <a:off x="9377157" y="3789457"/>
                <a:ext cx="2219313" cy="2829534"/>
                <a:chOff x="9377158" y="3849754"/>
                <a:chExt cx="2073766" cy="2643966"/>
              </a:xfrm>
            </p:grpSpPr>
            <p:pic>
              <p:nvPicPr>
                <p:cNvPr id="52" name="Picture 51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D0445E6A-C016-064F-F18E-A9FFA6658B9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881" t="11069" r="572" b="1258"/>
                <a:stretch/>
              </p:blipFill>
              <p:spPr>
                <a:xfrm>
                  <a:off x="9377158" y="4007325"/>
                  <a:ext cx="2073766" cy="2486395"/>
                </a:xfrm>
                <a:prstGeom prst="rect">
                  <a:avLst/>
                </a:prstGeom>
              </p:spPr>
            </p:pic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2D7F08F5-A8C2-4AF5-AD51-2AA320B1736D}"/>
                    </a:ext>
                  </a:extLst>
                </p:cNvPr>
                <p:cNvSpPr txBox="1"/>
                <p:nvPr/>
              </p:nvSpPr>
              <p:spPr>
                <a:xfrm>
                  <a:off x="9756020" y="3849754"/>
                  <a:ext cx="1406154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ccinic acid (</a:t>
                  </a:r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uc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5943378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>
            <a:extLst>
              <a:ext uri="{FF2B5EF4-FFF2-40B4-BE49-F238E27FC236}">
                <a16:creationId xmlns:a16="http://schemas.microsoft.com/office/drawing/2014/main" id="{F90255F6-4931-7DB2-EEB7-91FB7B135CAF}"/>
              </a:ext>
            </a:extLst>
          </p:cNvPr>
          <p:cNvGrpSpPr/>
          <p:nvPr/>
        </p:nvGrpSpPr>
        <p:grpSpPr>
          <a:xfrm>
            <a:off x="746048" y="53625"/>
            <a:ext cx="10152175" cy="3259757"/>
            <a:chOff x="1014032" y="99550"/>
            <a:chExt cx="10672293" cy="3426761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3A3D9535-862D-EB0D-0A5B-A63A40621A75}"/>
                </a:ext>
              </a:extLst>
            </p:cNvPr>
            <p:cNvGrpSpPr/>
            <p:nvPr/>
          </p:nvGrpSpPr>
          <p:grpSpPr>
            <a:xfrm>
              <a:off x="1014032" y="466309"/>
              <a:ext cx="10672293" cy="3060002"/>
              <a:chOff x="280787" y="105786"/>
              <a:chExt cx="10672293" cy="3060002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BC94F5C8-2D21-0B17-3ADD-BC895022EB80}"/>
                  </a:ext>
                </a:extLst>
              </p:cNvPr>
              <p:cNvGrpSpPr/>
              <p:nvPr/>
            </p:nvGrpSpPr>
            <p:grpSpPr>
              <a:xfrm>
                <a:off x="3083142" y="171841"/>
                <a:ext cx="2367720" cy="2980095"/>
                <a:chOff x="6110456" y="185729"/>
                <a:chExt cx="2406345" cy="3028710"/>
              </a:xfrm>
            </p:grpSpPr>
            <p:pic>
              <p:nvPicPr>
                <p:cNvPr id="13" name="Picture 12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D6BC028E-7148-E3DD-C929-403B4487B4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978" t="11156" r="-102" b="952"/>
                <a:stretch/>
              </p:blipFill>
              <p:spPr>
                <a:xfrm>
                  <a:off x="6110456" y="356761"/>
                  <a:ext cx="2406345" cy="2857678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DBBFC676-AC21-777F-72C1-CADC5A68F31C}"/>
                    </a:ext>
                  </a:extLst>
                </p:cNvPr>
                <p:cNvSpPr txBox="1"/>
                <p:nvPr/>
              </p:nvSpPr>
              <p:spPr>
                <a:xfrm>
                  <a:off x="6757487" y="185729"/>
                  <a:ext cx="1741592" cy="4001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i="0" u="none" strike="noStrike" baseline="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r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d18:1/22:0) 	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45229A40-8281-C8C4-4477-E0B2126F5B20}"/>
                  </a:ext>
                </a:extLst>
              </p:cNvPr>
              <p:cNvGrpSpPr/>
              <p:nvPr/>
            </p:nvGrpSpPr>
            <p:grpSpPr>
              <a:xfrm>
                <a:off x="5793179" y="105786"/>
                <a:ext cx="2331057" cy="3038309"/>
                <a:chOff x="9060115" y="166771"/>
                <a:chExt cx="2331057" cy="3038309"/>
              </a:xfrm>
            </p:grpSpPr>
            <p:pic>
              <p:nvPicPr>
                <p:cNvPr id="16" name="Picture 15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0ACE67E2-7191-192A-B792-FC9C07F375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917" t="11331" b="1089"/>
                <a:stretch/>
              </p:blipFill>
              <p:spPr>
                <a:xfrm>
                  <a:off x="9060115" y="444319"/>
                  <a:ext cx="2331057" cy="2760761"/>
                </a:xfrm>
                <a:prstGeom prst="rect">
                  <a:avLst/>
                </a:prstGeom>
              </p:spPr>
            </p:pic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5C5E04A3-377B-36A0-C278-24648ABB7F49}"/>
                    </a:ext>
                  </a:extLst>
                </p:cNvPr>
                <p:cNvSpPr txBox="1"/>
                <p:nvPr/>
              </p:nvSpPr>
              <p:spPr>
                <a:xfrm>
                  <a:off x="9513128" y="166771"/>
                  <a:ext cx="1741592" cy="4001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i="0" u="none" strike="noStrike" baseline="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r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d18:1/2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0) 	</a:t>
                  </a:r>
                </a:p>
              </p:txBody>
            </p:sp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A61C5AE1-DA6A-B372-1027-C96A202DA6B2}"/>
                  </a:ext>
                </a:extLst>
              </p:cNvPr>
              <p:cNvGrpSpPr/>
              <p:nvPr/>
            </p:nvGrpSpPr>
            <p:grpSpPr>
              <a:xfrm>
                <a:off x="280787" y="183280"/>
                <a:ext cx="2294524" cy="2982508"/>
                <a:chOff x="338398" y="3292182"/>
                <a:chExt cx="2294524" cy="2982508"/>
              </a:xfrm>
            </p:grpSpPr>
            <p:pic>
              <p:nvPicPr>
                <p:cNvPr id="19" name="Picture 18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72DE6880-249D-0F1D-B9F2-6E35F33A0DC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094" t="11331" r="1089"/>
                <a:stretch/>
              </p:blipFill>
              <p:spPr>
                <a:xfrm>
                  <a:off x="338398" y="3449030"/>
                  <a:ext cx="2294524" cy="2825660"/>
                </a:xfrm>
                <a:prstGeom prst="rect">
                  <a:avLst/>
                </a:prstGeom>
              </p:spPr>
            </p:pic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BDF43E4E-7D73-A829-197C-05D13F7158CA}"/>
                    </a:ext>
                  </a:extLst>
                </p:cNvPr>
                <p:cNvSpPr txBox="1"/>
                <p:nvPr/>
              </p:nvSpPr>
              <p:spPr>
                <a:xfrm>
                  <a:off x="882611" y="3292182"/>
                  <a:ext cx="1741592" cy="4001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i="0" u="none" strike="noStrike" baseline="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r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d18:1/24:1) 	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CB6FA695-2C4D-A087-6969-5A7F3A096931}"/>
                  </a:ext>
                </a:extLst>
              </p:cNvPr>
              <p:cNvGrpSpPr/>
              <p:nvPr/>
            </p:nvGrpSpPr>
            <p:grpSpPr>
              <a:xfrm>
                <a:off x="8646297" y="153667"/>
                <a:ext cx="2306783" cy="2972700"/>
                <a:chOff x="8646297" y="153667"/>
                <a:chExt cx="2306783" cy="2972700"/>
              </a:xfrm>
            </p:grpSpPr>
            <p:pic>
              <p:nvPicPr>
                <p:cNvPr id="25" name="Picture 24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0B026926-9A26-F1C4-856D-75D048AB27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182" t="11608"/>
                <a:stretch/>
              </p:blipFill>
              <p:spPr>
                <a:xfrm>
                  <a:off x="8646297" y="410788"/>
                  <a:ext cx="2259306" cy="2715579"/>
                </a:xfrm>
                <a:prstGeom prst="rect">
                  <a:avLst/>
                </a:prstGeom>
              </p:spPr>
            </p:pic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522B72D4-2423-3223-ECC5-8063DA170BE4}"/>
                    </a:ext>
                  </a:extLst>
                </p:cNvPr>
                <p:cNvSpPr txBox="1"/>
                <p:nvPr/>
              </p:nvSpPr>
              <p:spPr>
                <a:xfrm>
                  <a:off x="9211488" y="153667"/>
                  <a:ext cx="1741592" cy="4001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i="0" u="none" strike="noStrike" baseline="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r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d18:2/18:0) 	</a:t>
                  </a:r>
                </a:p>
              </p:txBody>
            </p:sp>
          </p:grp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BD6F3CE-BF75-6987-EF0F-7A262146AA69}"/>
                </a:ext>
              </a:extLst>
            </p:cNvPr>
            <p:cNvSpPr txBox="1"/>
            <p:nvPr/>
          </p:nvSpPr>
          <p:spPr>
            <a:xfrm>
              <a:off x="5794257" y="99550"/>
              <a:ext cx="146433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ramides 	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E8AA6629-9FB5-DA0D-A21D-06DA2EDE7976}"/>
              </a:ext>
            </a:extLst>
          </p:cNvPr>
          <p:cNvGrpSpPr/>
          <p:nvPr/>
        </p:nvGrpSpPr>
        <p:grpSpPr>
          <a:xfrm>
            <a:off x="694483" y="3429000"/>
            <a:ext cx="10328748" cy="3280895"/>
            <a:chOff x="1116732" y="3349587"/>
            <a:chExt cx="10328748" cy="3280895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F3CB9D8E-F9E4-1AF1-FA23-E9A716A96724}"/>
                </a:ext>
              </a:extLst>
            </p:cNvPr>
            <p:cNvGrpSpPr/>
            <p:nvPr/>
          </p:nvGrpSpPr>
          <p:grpSpPr>
            <a:xfrm>
              <a:off x="1116732" y="3473406"/>
              <a:ext cx="10328748" cy="3157076"/>
              <a:chOff x="642280" y="3636925"/>
              <a:chExt cx="10328748" cy="3157076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05815FCF-5EF1-1DAD-6841-27E8715DD6D7}"/>
                  </a:ext>
                </a:extLst>
              </p:cNvPr>
              <p:cNvGrpSpPr/>
              <p:nvPr/>
            </p:nvGrpSpPr>
            <p:grpSpPr>
              <a:xfrm>
                <a:off x="642280" y="3636925"/>
                <a:ext cx="2253530" cy="3053655"/>
                <a:chOff x="671874" y="168654"/>
                <a:chExt cx="2253530" cy="3053655"/>
              </a:xfrm>
            </p:grpSpPr>
            <p:pic>
              <p:nvPicPr>
                <p:cNvPr id="3" name="Picture 2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A368E409-C4C9-87FE-13C0-BEDB5C5662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86" t="10746"/>
                <a:stretch/>
              </p:blipFill>
              <p:spPr>
                <a:xfrm>
                  <a:off x="671874" y="469777"/>
                  <a:ext cx="2253530" cy="2752532"/>
                </a:xfrm>
                <a:prstGeom prst="rect">
                  <a:avLst/>
                </a:prstGeom>
              </p:spPr>
            </p:pic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FD72B660-F2A7-ECA4-8276-94CBFC1F59B3}"/>
                    </a:ext>
                  </a:extLst>
                </p:cNvPr>
                <p:cNvSpPr txBox="1"/>
                <p:nvPr/>
              </p:nvSpPr>
              <p:spPr>
                <a:xfrm>
                  <a:off x="1173721" y="168654"/>
                  <a:ext cx="1531848" cy="55399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endParaRPr lang="en-US" sz="1000" b="1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x3Cer(d18:1/24:1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EF62661C-89FF-C97E-8784-84DB1D8F805C}"/>
                  </a:ext>
                </a:extLst>
              </p:cNvPr>
              <p:cNvGrpSpPr/>
              <p:nvPr/>
            </p:nvGrpSpPr>
            <p:grpSpPr>
              <a:xfrm>
                <a:off x="3366214" y="3808440"/>
                <a:ext cx="2289496" cy="2985561"/>
                <a:chOff x="4107890" y="300252"/>
                <a:chExt cx="2395012" cy="3123156"/>
              </a:xfrm>
            </p:grpSpPr>
            <p:pic>
              <p:nvPicPr>
                <p:cNvPr id="7" name="Picture 6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A6E07FA6-B294-B2AB-1260-5678A8694A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477" t="11054"/>
                <a:stretch/>
              </p:blipFill>
              <p:spPr>
                <a:xfrm>
                  <a:off x="4107890" y="508712"/>
                  <a:ext cx="2395012" cy="2914696"/>
                </a:xfrm>
                <a:prstGeom prst="rect">
                  <a:avLst/>
                </a:prstGeom>
              </p:spPr>
            </p:pic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DFCB0412-EA3D-410E-1148-9FC9886337AD}"/>
                    </a:ext>
                  </a:extLst>
                </p:cNvPr>
                <p:cNvSpPr txBox="1"/>
                <p:nvPr/>
              </p:nvSpPr>
              <p:spPr>
                <a:xfrm>
                  <a:off x="4624812" y="300252"/>
                  <a:ext cx="1821857" cy="4001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b="1" i="0" u="none" strike="noStrike" baseline="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xCer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d18:1/24:0) 	</a:t>
                  </a:r>
                </a:p>
              </p:txBody>
            </p: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A77F3F33-A2DA-B44F-3AC9-DAD14D318C03}"/>
                  </a:ext>
                </a:extLst>
              </p:cNvPr>
              <p:cNvGrpSpPr/>
              <p:nvPr/>
            </p:nvGrpSpPr>
            <p:grpSpPr>
              <a:xfrm>
                <a:off x="5966916" y="3697772"/>
                <a:ext cx="2300144" cy="3054442"/>
                <a:chOff x="5878890" y="3744905"/>
                <a:chExt cx="2300144" cy="3054442"/>
              </a:xfrm>
            </p:grpSpPr>
            <p:pic>
              <p:nvPicPr>
                <p:cNvPr id="29" name="Picture 28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ACB92E08-14D0-8691-467C-36BB66DED8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990" t="11176" r="409" b="1219"/>
                <a:stretch/>
              </p:blipFill>
              <p:spPr>
                <a:xfrm>
                  <a:off x="5878890" y="4046815"/>
                  <a:ext cx="2300144" cy="2752532"/>
                </a:xfrm>
                <a:prstGeom prst="rect">
                  <a:avLst/>
                </a:prstGeom>
              </p:spPr>
            </p:pic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F5B4F218-35A9-5C56-3E25-3FBAF27B5048}"/>
                    </a:ext>
                  </a:extLst>
                </p:cNvPr>
                <p:cNvSpPr txBox="1"/>
                <p:nvPr/>
              </p:nvSpPr>
              <p:spPr>
                <a:xfrm>
                  <a:off x="6406210" y="3744905"/>
                  <a:ext cx="1531848" cy="55399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endParaRPr lang="en-US" sz="1000" b="1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x3Cer(d18:1/16:0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</a:p>
              </p:txBody>
            </p:sp>
          </p:grp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D537EF9A-540B-1B80-0008-675C3E64ED9B}"/>
                  </a:ext>
                </a:extLst>
              </p:cNvPr>
              <p:cNvGrpSpPr/>
              <p:nvPr/>
            </p:nvGrpSpPr>
            <p:grpSpPr>
              <a:xfrm>
                <a:off x="8735860" y="3642974"/>
                <a:ext cx="2235168" cy="3047606"/>
                <a:chOff x="8668828" y="3658142"/>
                <a:chExt cx="2235168" cy="3047606"/>
              </a:xfrm>
            </p:grpSpPr>
            <p:pic>
              <p:nvPicPr>
                <p:cNvPr id="32" name="Picture 31" descr="A screenshot of a graph&#10;&#10;Description automatically generated">
                  <a:extLst>
                    <a:ext uri="{FF2B5EF4-FFF2-40B4-BE49-F238E27FC236}">
                      <a16:creationId xmlns:a16="http://schemas.microsoft.com/office/drawing/2014/main" id="{3AF3DE8C-EBA1-DE53-E3C7-F74DAA719E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235" t="11176"/>
                <a:stretch/>
              </p:blipFill>
              <p:spPr>
                <a:xfrm>
                  <a:off x="8668828" y="4003038"/>
                  <a:ext cx="2235168" cy="2702710"/>
                </a:xfrm>
                <a:prstGeom prst="rect">
                  <a:avLst/>
                </a:prstGeom>
              </p:spPr>
            </p:pic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F88E3D7E-A783-D14B-57BD-5A4834F9E8C2}"/>
                    </a:ext>
                  </a:extLst>
                </p:cNvPr>
                <p:cNvSpPr txBox="1"/>
                <p:nvPr/>
              </p:nvSpPr>
              <p:spPr>
                <a:xfrm>
                  <a:off x="9092310" y="3658142"/>
                  <a:ext cx="1531848" cy="55399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endParaRPr lang="en-US" sz="1000" b="1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x3Cer(d18:1/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:0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r>
                    <a:rPr lang="en-US" sz="1000" b="1" i="0" u="none" strike="noStrike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	</a:t>
                  </a:r>
                </a:p>
              </p:txBody>
            </p:sp>
          </p:grp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EC0E490-9EEF-81DF-E9A9-4A1B1F798484}"/>
                </a:ext>
              </a:extLst>
            </p:cNvPr>
            <p:cNvSpPr txBox="1"/>
            <p:nvPr/>
          </p:nvSpPr>
          <p:spPr>
            <a:xfrm>
              <a:off x="5436840" y="3349587"/>
              <a:ext cx="1531848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0" u="none" strike="noStrike" baseline="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xosylceramides</a:t>
              </a:r>
              <a:r>
                <a:rPr lang="en-US" sz="1200" b="1" i="0" u="none" strike="noStrike" baseline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	</a:t>
              </a:r>
            </a:p>
          </p:txBody>
        </p:sp>
      </p:grpSp>
      <p:sp>
        <p:nvSpPr>
          <p:cNvPr id="44" name="TextBox 14">
            <a:extLst>
              <a:ext uri="{FF2B5EF4-FFF2-40B4-BE49-F238E27FC236}">
                <a16:creationId xmlns:a16="http://schemas.microsoft.com/office/drawing/2014/main" id="{1FFF1399-2855-ADBE-B5F1-02318136787D}"/>
              </a:ext>
            </a:extLst>
          </p:cNvPr>
          <p:cNvSpPr txBox="1"/>
          <p:nvPr/>
        </p:nvSpPr>
        <p:spPr>
          <a:xfrm>
            <a:off x="9474856" y="9611"/>
            <a:ext cx="2194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: S6E</a:t>
            </a:r>
          </a:p>
        </p:txBody>
      </p:sp>
    </p:spTree>
    <p:extLst>
      <p:ext uri="{BB962C8B-B14F-4D97-AF65-F5344CB8AC3E}">
        <p14:creationId xmlns:p14="http://schemas.microsoft.com/office/powerpoint/2010/main" val="42663952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>
            <a:extLst>
              <a:ext uri="{FF2B5EF4-FFF2-40B4-BE49-F238E27FC236}">
                <a16:creationId xmlns:a16="http://schemas.microsoft.com/office/drawing/2014/main" id="{B87D05E6-C25C-BC7B-BC60-2E2F1CAD11EF}"/>
              </a:ext>
            </a:extLst>
          </p:cNvPr>
          <p:cNvGrpSpPr/>
          <p:nvPr/>
        </p:nvGrpSpPr>
        <p:grpSpPr>
          <a:xfrm>
            <a:off x="794943" y="47923"/>
            <a:ext cx="11026626" cy="6810077"/>
            <a:chOff x="794943" y="47923"/>
            <a:chExt cx="11026626" cy="6810077"/>
          </a:xfrm>
        </p:grpSpPr>
        <p:sp>
          <p:nvSpPr>
            <p:cNvPr id="22" name="TextBox 14">
              <a:extLst>
                <a:ext uri="{FF2B5EF4-FFF2-40B4-BE49-F238E27FC236}">
                  <a16:creationId xmlns:a16="http://schemas.microsoft.com/office/drawing/2014/main" id="{84A06370-1493-4A35-8C21-E2739571D0BB}"/>
                </a:ext>
              </a:extLst>
            </p:cNvPr>
            <p:cNvSpPr txBox="1"/>
            <p:nvPr/>
          </p:nvSpPr>
          <p:spPr>
            <a:xfrm>
              <a:off x="9634752" y="47923"/>
              <a:ext cx="21868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: S6F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A01939EF-D76A-589E-3635-27B900ED8475}"/>
                </a:ext>
              </a:extLst>
            </p:cNvPr>
            <p:cNvGrpSpPr/>
            <p:nvPr/>
          </p:nvGrpSpPr>
          <p:grpSpPr>
            <a:xfrm>
              <a:off x="2587284" y="3655155"/>
              <a:ext cx="2223948" cy="3127746"/>
              <a:chOff x="1077951" y="3665800"/>
              <a:chExt cx="2223948" cy="3127746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AFFAA16F-C16F-4768-A231-81621EC8E07D}"/>
                  </a:ext>
                </a:extLst>
              </p:cNvPr>
              <p:cNvSpPr txBox="1"/>
              <p:nvPr/>
            </p:nvSpPr>
            <p:spPr>
              <a:xfrm>
                <a:off x="1420251" y="3665800"/>
                <a:ext cx="17897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and cofactors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1EF93FB-03FF-4C40-A9C9-621D026E76A6}"/>
                  </a:ext>
                </a:extLst>
              </p:cNvPr>
              <p:cNvSpPr txBox="1"/>
              <p:nvPr/>
            </p:nvSpPr>
            <p:spPr>
              <a:xfrm>
                <a:off x="1942612" y="3893170"/>
                <a:ext cx="761670" cy="2782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ine</a:t>
                </a:r>
              </a:p>
            </p:txBody>
          </p:sp>
          <p:pic>
            <p:nvPicPr>
              <p:cNvPr id="7" name="Picture 6" descr="A screenshot of a graph&#10;&#10;Description automatically generated">
                <a:extLst>
                  <a:ext uri="{FF2B5EF4-FFF2-40B4-BE49-F238E27FC236}">
                    <a16:creationId xmlns:a16="http://schemas.microsoft.com/office/drawing/2014/main" id="{04E23D5B-37A5-1355-4DCB-29045E90BE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536" t="11021" b="140"/>
              <a:stretch/>
            </p:blipFill>
            <p:spPr>
              <a:xfrm>
                <a:off x="1077951" y="4086922"/>
                <a:ext cx="2223948" cy="2706624"/>
              </a:xfrm>
              <a:prstGeom prst="rect">
                <a:avLst/>
              </a:prstGeom>
            </p:spPr>
          </p:pic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3106B6C9-4F8E-1099-8136-A246D50AA612}"/>
                </a:ext>
              </a:extLst>
            </p:cNvPr>
            <p:cNvGrpSpPr/>
            <p:nvPr/>
          </p:nvGrpSpPr>
          <p:grpSpPr>
            <a:xfrm>
              <a:off x="5774604" y="3692168"/>
              <a:ext cx="2275309" cy="3165832"/>
              <a:chOff x="9265242" y="1541378"/>
              <a:chExt cx="2275309" cy="3165832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CD233AF1-E7F2-41F1-8796-809CC1ED748D}"/>
                  </a:ext>
                </a:extLst>
              </p:cNvPr>
              <p:cNvGrpSpPr/>
              <p:nvPr/>
            </p:nvGrpSpPr>
            <p:grpSpPr>
              <a:xfrm>
                <a:off x="9563563" y="1541378"/>
                <a:ext cx="1678665" cy="459208"/>
                <a:chOff x="8379474" y="607100"/>
                <a:chExt cx="1678665" cy="459208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584F8D51-7C2D-4043-A401-319EDFD284B0}"/>
                    </a:ext>
                  </a:extLst>
                </p:cNvPr>
                <p:cNvSpPr txBox="1"/>
                <p:nvPr/>
              </p:nvSpPr>
              <p:spPr>
                <a:xfrm>
                  <a:off x="8379474" y="607100"/>
                  <a:ext cx="167866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ucleobases related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CDBFF5F-F434-4D7B-BC69-E960EB45A80E}"/>
                    </a:ext>
                  </a:extLst>
                </p:cNvPr>
                <p:cNvSpPr txBox="1"/>
                <p:nvPr/>
              </p:nvSpPr>
              <p:spPr>
                <a:xfrm>
                  <a:off x="8847138" y="820087"/>
                  <a:ext cx="103105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ypoxanthine</a:t>
                  </a:r>
                </a:p>
              </p:txBody>
            </p:sp>
          </p:grpSp>
          <p:pic>
            <p:nvPicPr>
              <p:cNvPr id="11" name="Picture 10" descr="A screenshot of a graph&#10;&#10;Description automatically generated">
                <a:extLst>
                  <a:ext uri="{FF2B5EF4-FFF2-40B4-BE49-F238E27FC236}">
                    <a16:creationId xmlns:a16="http://schemas.microsoft.com/office/drawing/2014/main" id="{BDB9A0EE-FE93-8EEC-1BE2-6CA59D0AC7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886" t="11837" b="140"/>
              <a:stretch/>
            </p:blipFill>
            <p:spPr>
              <a:xfrm>
                <a:off x="9265242" y="2000586"/>
                <a:ext cx="2275309" cy="2706624"/>
              </a:xfrm>
              <a:prstGeom prst="rect">
                <a:avLst/>
              </a:prstGeom>
            </p:spPr>
          </p:pic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7769DBD4-154F-DC90-C8E0-1CAAC3C0C37C}"/>
                </a:ext>
              </a:extLst>
            </p:cNvPr>
            <p:cNvGrpSpPr/>
            <p:nvPr/>
          </p:nvGrpSpPr>
          <p:grpSpPr>
            <a:xfrm>
              <a:off x="794943" y="605099"/>
              <a:ext cx="9411224" cy="2935639"/>
              <a:chOff x="-466222" y="193386"/>
              <a:chExt cx="9411224" cy="2935639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066DC5AC-84E9-1A1B-3077-9A77F7C2066F}"/>
                  </a:ext>
                </a:extLst>
              </p:cNvPr>
              <p:cNvGrpSpPr/>
              <p:nvPr/>
            </p:nvGrpSpPr>
            <p:grpSpPr>
              <a:xfrm>
                <a:off x="550046" y="193386"/>
                <a:ext cx="8394956" cy="2935639"/>
                <a:chOff x="550046" y="193386"/>
                <a:chExt cx="8394956" cy="2935639"/>
              </a:xfrm>
            </p:grpSpPr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B3878BBF-EEBA-4D23-96FC-DD127510BEDC}"/>
                    </a:ext>
                  </a:extLst>
                </p:cNvPr>
                <p:cNvGrpSpPr/>
                <p:nvPr/>
              </p:nvGrpSpPr>
              <p:grpSpPr>
                <a:xfrm>
                  <a:off x="550046" y="193386"/>
                  <a:ext cx="2236746" cy="2905933"/>
                  <a:chOff x="299880" y="210491"/>
                  <a:chExt cx="2236746" cy="2905933"/>
                </a:xfrm>
              </p:grpSpPr>
              <p:pic>
                <p:nvPicPr>
                  <p:cNvPr id="47" name="Picture 46" descr="A comparison of a graph&#10;&#10;Description automatically generated with medium confidence">
                    <a:extLst>
                      <a:ext uri="{FF2B5EF4-FFF2-40B4-BE49-F238E27FC236}">
                        <a16:creationId xmlns:a16="http://schemas.microsoft.com/office/drawing/2014/main" id="{31347FEC-6BDF-2D1B-B2D1-50231E88134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183" t="11157" r="577" b="953"/>
                  <a:stretch/>
                </p:blipFill>
                <p:spPr>
                  <a:xfrm>
                    <a:off x="299880" y="410546"/>
                    <a:ext cx="2236746" cy="2705878"/>
                  </a:xfrm>
                  <a:prstGeom prst="rect">
                    <a:avLst/>
                  </a:prstGeom>
                </p:spPr>
              </p:pic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2E208E95-0A76-8EE2-9124-A3CF33300FD7}"/>
                      </a:ext>
                    </a:extLst>
                  </p:cNvPr>
                  <p:cNvSpPr txBox="1"/>
                  <p:nvPr/>
                </p:nvSpPr>
                <p:spPr>
                  <a:xfrm>
                    <a:off x="1031891" y="210491"/>
                    <a:ext cx="1185098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rnitine (C0) 	</a:t>
                    </a:r>
                  </a:p>
                </p:txBody>
              </p: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53B36026-C26D-8791-A547-3331B596F319}"/>
                    </a:ext>
                  </a:extLst>
                </p:cNvPr>
                <p:cNvGrpSpPr/>
                <p:nvPr/>
              </p:nvGrpSpPr>
              <p:grpSpPr>
                <a:xfrm>
                  <a:off x="3649480" y="193386"/>
                  <a:ext cx="2367793" cy="2935639"/>
                  <a:chOff x="3649480" y="193386"/>
                  <a:chExt cx="2367793" cy="2935639"/>
                </a:xfrm>
              </p:grpSpPr>
              <p:pic>
                <p:nvPicPr>
                  <p:cNvPr id="45" name="Picture 44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61CB0036-982D-ACB2-C5CD-5C854EB6E8B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270" t="11429" b="1089"/>
                  <a:stretch/>
                </p:blipFill>
                <p:spPr>
                  <a:xfrm>
                    <a:off x="3649480" y="422401"/>
                    <a:ext cx="2271058" cy="2706624"/>
                  </a:xfrm>
                  <a:prstGeom prst="rect">
                    <a:avLst/>
                  </a:prstGeom>
                </p:spPr>
              </p:pic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0C16E65E-D657-CC8B-BC0D-A006AA58C9D3}"/>
                      </a:ext>
                    </a:extLst>
                  </p:cNvPr>
                  <p:cNvSpPr txBox="1"/>
                  <p:nvPr/>
                </p:nvSpPr>
                <p:spPr>
                  <a:xfrm>
                    <a:off x="3780526" y="193386"/>
                    <a:ext cx="2236747" cy="246221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i="0" u="none" strike="noStrike" baseline="0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odecanedioylcarnitine</a:t>
                    </a:r>
                    <a:r>
                      <a:rPr lang="en-US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C12-DC)</a:t>
                    </a:r>
                  </a:p>
                </p:txBody>
              </p:sp>
            </p:grpSp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6502762B-DF10-4B69-8303-F90C3B56C28F}"/>
                    </a:ext>
                  </a:extLst>
                </p:cNvPr>
                <p:cNvGrpSpPr/>
                <p:nvPr/>
              </p:nvGrpSpPr>
              <p:grpSpPr>
                <a:xfrm>
                  <a:off x="6688679" y="193386"/>
                  <a:ext cx="2256323" cy="2877618"/>
                  <a:chOff x="6777605" y="239552"/>
                  <a:chExt cx="2256323" cy="2877618"/>
                </a:xfrm>
              </p:grpSpPr>
              <p:pic>
                <p:nvPicPr>
                  <p:cNvPr id="43" name="Picture 42" descr="A screenshot of a graph&#10;&#10;Description automatically generated">
                    <a:extLst>
                      <a:ext uri="{FF2B5EF4-FFF2-40B4-BE49-F238E27FC236}">
                        <a16:creationId xmlns:a16="http://schemas.microsoft.com/office/drawing/2014/main" id="{AB5F1D76-2CB9-6AD0-4EA9-EE75CAB595A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2359" t="11021" b="1089"/>
                  <a:stretch/>
                </p:blipFill>
                <p:spPr>
                  <a:xfrm>
                    <a:off x="6777605" y="410546"/>
                    <a:ext cx="2256323" cy="2706624"/>
                  </a:xfrm>
                  <a:prstGeom prst="rect">
                    <a:avLst/>
                  </a:prstGeom>
                </p:spPr>
              </p:pic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073AFBC6-8DAB-3626-84F2-FA97C173EDB0}"/>
                      </a:ext>
                    </a:extLst>
                  </p:cNvPr>
                  <p:cNvSpPr txBox="1"/>
                  <p:nvPr/>
                </p:nvSpPr>
                <p:spPr>
                  <a:xfrm>
                    <a:off x="7369380" y="239552"/>
                    <a:ext cx="1584839" cy="400110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000" b="1" i="0" u="none" strike="noStrike" baseline="0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utyrylcarnitine</a:t>
                    </a:r>
                    <a:r>
                      <a:rPr lang="en-US" sz="1000" b="1" i="0" u="none" strike="noStrik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	</a:t>
                    </a:r>
                  </a:p>
                </p:txBody>
              </p:sp>
            </p:grpSp>
          </p:grp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E1B70EF-6137-414C-F6B2-F75C688FC813}"/>
                  </a:ext>
                </a:extLst>
              </p:cNvPr>
              <p:cNvSpPr txBox="1"/>
              <p:nvPr/>
            </p:nvSpPr>
            <p:spPr>
              <a:xfrm>
                <a:off x="-466222" y="300288"/>
                <a:ext cx="1412576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i="0" u="none" strike="noStrike" baseline="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ylcarnitines</a:t>
                </a:r>
                <a:r>
                  <a:rPr lang="en-US" sz="1200" b="1" i="0" u="none" strike="noStrike" baseline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	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06119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7</TotalTime>
  <Words>203</Words>
  <Application>Microsoft Office PowerPoint</Application>
  <PresentationFormat>Widescreen</PresentationFormat>
  <Paragraphs>5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ul Quaiyoom Khan</dc:creator>
  <cp:lastModifiedBy>Abdul Quaiyoom Khan</cp:lastModifiedBy>
  <cp:revision>31</cp:revision>
  <dcterms:created xsi:type="dcterms:W3CDTF">2023-09-12T10:24:49Z</dcterms:created>
  <dcterms:modified xsi:type="dcterms:W3CDTF">2024-05-12T06:08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3-09-12T10:24:49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91ff10d1-fd84-4592-a69c-d18d70443488</vt:lpwstr>
  </property>
  <property fmtid="{D5CDD505-2E9C-101B-9397-08002B2CF9AE}" pid="8" name="MSIP_Label_573f5887-035d-4765-8d10-97aaac8deb4a_ContentBits">
    <vt:lpwstr>0</vt:lpwstr>
  </property>
</Properties>
</file>